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4"/>
  </p:sldMasterIdLst>
  <p:notesMasterIdLst>
    <p:notesMasterId r:id="rId11"/>
  </p:notesMasterIdLst>
  <p:sldIdLst>
    <p:sldId id="501" r:id="rId5"/>
    <p:sldId id="499" r:id="rId6"/>
    <p:sldId id="514" r:id="rId7"/>
    <p:sldId id="521" r:id="rId8"/>
    <p:sldId id="495" r:id="rId9"/>
    <p:sldId id="511" r:id="rId10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60">
          <p15:clr>
            <a:srgbClr val="A4A3A4"/>
          </p15:clr>
        </p15:guide>
        <p15:guide id="2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17C3DBB-E3FD-4DAE-89E1-E909C7961BF5}" v="2" dt="2023-08-17T17:41:58.11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15" autoAdjust="0"/>
    <p:restoredTop sz="98765" autoAdjust="0"/>
  </p:normalViewPr>
  <p:slideViewPr>
    <p:cSldViewPr snapToGrid="0">
      <p:cViewPr varScale="1">
        <p:scale>
          <a:sx n="62" d="100"/>
          <a:sy n="62" d="100"/>
        </p:scale>
        <p:origin x="2501" y="62"/>
      </p:cViewPr>
      <p:guideLst>
        <p:guide orient="horz" pos="5460"/>
        <p:guide pos="431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lik Hamaidia" userId="cb6d47f9ad5e5995" providerId="LiveId" clId="{317C3DBB-E3FD-4DAE-89E1-E909C7961BF5}"/>
    <pc:docChg chg="addSld delSld modSld">
      <pc:chgData name="Malik Hamaidia" userId="cb6d47f9ad5e5995" providerId="LiveId" clId="{317C3DBB-E3FD-4DAE-89E1-E909C7961BF5}" dt="2023-08-17T18:08:14.012" v="10" actId="2696"/>
      <pc:docMkLst>
        <pc:docMk/>
      </pc:docMkLst>
      <pc:sldChg chg="del">
        <pc:chgData name="Malik Hamaidia" userId="cb6d47f9ad5e5995" providerId="LiveId" clId="{317C3DBB-E3FD-4DAE-89E1-E909C7961BF5}" dt="2023-08-17T17:29:37.582" v="6" actId="47"/>
        <pc:sldMkLst>
          <pc:docMk/>
          <pc:sldMk cId="2474595232" sldId="506"/>
        </pc:sldMkLst>
      </pc:sldChg>
      <pc:sldChg chg="addSp delSp modSp mod">
        <pc:chgData name="Malik Hamaidia" userId="cb6d47f9ad5e5995" providerId="LiveId" clId="{317C3DBB-E3FD-4DAE-89E1-E909C7961BF5}" dt="2023-08-17T17:41:58.794" v="9"/>
        <pc:sldMkLst>
          <pc:docMk/>
          <pc:sldMk cId="2412886110" sldId="511"/>
        </pc:sldMkLst>
        <pc:spChg chg="add del mod">
          <ac:chgData name="Malik Hamaidia" userId="cb6d47f9ad5e5995" providerId="LiveId" clId="{317C3DBB-E3FD-4DAE-89E1-E909C7961BF5}" dt="2023-08-17T17:41:58.794" v="9"/>
          <ac:spMkLst>
            <pc:docMk/>
            <pc:sldMk cId="2412886110" sldId="511"/>
            <ac:spMk id="2" creationId="{F3C494FC-6142-860A-7210-E5C6921FC215}"/>
          </ac:spMkLst>
        </pc:spChg>
      </pc:sldChg>
      <pc:sldChg chg="del">
        <pc:chgData name="Malik Hamaidia" userId="cb6d47f9ad5e5995" providerId="LiveId" clId="{317C3DBB-E3FD-4DAE-89E1-E909C7961BF5}" dt="2023-08-17T18:08:14.012" v="10" actId="2696"/>
        <pc:sldMkLst>
          <pc:docMk/>
          <pc:sldMk cId="2981207157" sldId="517"/>
        </pc:sldMkLst>
      </pc:sldChg>
      <pc:sldChg chg="del">
        <pc:chgData name="Malik Hamaidia" userId="cb6d47f9ad5e5995" providerId="LiveId" clId="{317C3DBB-E3FD-4DAE-89E1-E909C7961BF5}" dt="2023-08-17T18:08:14.012" v="10" actId="2696"/>
        <pc:sldMkLst>
          <pc:docMk/>
          <pc:sldMk cId="2107180337" sldId="518"/>
        </pc:sldMkLst>
      </pc:sldChg>
      <pc:sldChg chg="del">
        <pc:chgData name="Malik Hamaidia" userId="cb6d47f9ad5e5995" providerId="LiveId" clId="{317C3DBB-E3FD-4DAE-89E1-E909C7961BF5}" dt="2023-08-17T18:08:14.012" v="10" actId="2696"/>
        <pc:sldMkLst>
          <pc:docMk/>
          <pc:sldMk cId="2758613481" sldId="519"/>
        </pc:sldMkLst>
      </pc:sldChg>
      <pc:sldChg chg="del">
        <pc:chgData name="Malik Hamaidia" userId="cb6d47f9ad5e5995" providerId="LiveId" clId="{317C3DBB-E3FD-4DAE-89E1-E909C7961BF5}" dt="2023-08-17T18:08:14.012" v="10" actId="2696"/>
        <pc:sldMkLst>
          <pc:docMk/>
          <pc:sldMk cId="3094257670" sldId="520"/>
        </pc:sldMkLst>
      </pc:sldChg>
      <pc:sldChg chg="addSp modSp new del mod">
        <pc:chgData name="Malik Hamaidia" userId="cb6d47f9ad5e5995" providerId="LiveId" clId="{317C3DBB-E3FD-4DAE-89E1-E909C7961BF5}" dt="2023-08-17T18:08:14.012" v="10" actId="2696"/>
        <pc:sldMkLst>
          <pc:docMk/>
          <pc:sldMk cId="1227488437" sldId="522"/>
        </pc:sldMkLst>
        <pc:graphicFrameChg chg="add mod">
          <ac:chgData name="Malik Hamaidia" userId="cb6d47f9ad5e5995" providerId="LiveId" clId="{317C3DBB-E3FD-4DAE-89E1-E909C7961BF5}" dt="2023-08-17T14:22:04.059" v="4" actId="1076"/>
          <ac:graphicFrameMkLst>
            <pc:docMk/>
            <pc:sldMk cId="1227488437" sldId="522"/>
            <ac:graphicFrameMk id="2" creationId="{FBB84D6C-E6B0-2B45-3B5B-82610B84778A}"/>
          </ac:graphicFrameMkLst>
        </pc:graphicFrameChg>
        <pc:graphicFrameChg chg="add mod">
          <ac:chgData name="Malik Hamaidia" userId="cb6d47f9ad5e5995" providerId="LiveId" clId="{317C3DBB-E3FD-4DAE-89E1-E909C7961BF5}" dt="2023-08-17T14:22:08.084" v="5" actId="1076"/>
          <ac:graphicFrameMkLst>
            <pc:docMk/>
            <pc:sldMk cId="1227488437" sldId="522"/>
            <ac:graphicFrameMk id="3" creationId="{6CCB6FF8-1B87-8B17-2A88-88F3DD3FF326}"/>
          </ac:graphicFrameMkLst>
        </pc:graphicFrameChg>
        <pc:graphicFrameChg chg="add mod">
          <ac:chgData name="Malik Hamaidia" userId="cb6d47f9ad5e5995" providerId="LiveId" clId="{317C3DBB-E3FD-4DAE-89E1-E909C7961BF5}" dt="2023-08-17T14:22:02.778" v="3" actId="1076"/>
          <ac:graphicFrameMkLst>
            <pc:docMk/>
            <pc:sldMk cId="1227488437" sldId="522"/>
            <ac:graphicFrameMk id="4" creationId="{0F003870-458A-F2F2-962D-02769417174B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4470031:Desktop:UCN%20and%20caffeine%20MT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4470031:Desktop:UCN%20and%20caffeine%20MT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553816895769399"/>
          <c:y val="0.22662530354937099"/>
          <c:w val="0.73110036033631398"/>
          <c:h val="0.54954775542998202"/>
        </c:manualLayout>
      </c:layout>
      <c:lineChart>
        <c:grouping val="standard"/>
        <c:varyColors val="0"/>
        <c:ser>
          <c:idx val="0"/>
          <c:order val="0"/>
          <c:tx>
            <c:strRef>
              <c:f>'UCN&amp;Caffeine MTT graph madefrom'!$M$27</c:f>
              <c:strCache>
                <c:ptCount val="1"/>
                <c:pt idx="0">
                  <c:v>C643</c:v>
                </c:pt>
              </c:strCache>
            </c:strRef>
          </c:tx>
          <c:spPr>
            <a:ln w="28575" cmpd="sng"/>
          </c:spPr>
          <c:marker>
            <c:spPr>
              <a:ln w="28575" cmpd="sng"/>
            </c:spPr>
          </c:marker>
          <c:cat>
            <c:numRef>
              <c:f>'UCN&amp;Caffeine MTT graph madefrom'!$L$28:$L$32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.5</c:v>
                </c:pt>
                <c:pt idx="4">
                  <c:v>5</c:v>
                </c:pt>
              </c:numCache>
            </c:numRef>
          </c:cat>
          <c:val>
            <c:numRef>
              <c:f>'UCN&amp;Caffeine MTT graph madefrom'!$M$28:$M$32</c:f>
              <c:numCache>
                <c:formatCode>0</c:formatCode>
                <c:ptCount val="5"/>
                <c:pt idx="0">
                  <c:v>100</c:v>
                </c:pt>
                <c:pt idx="1">
                  <c:v>92.210996701652633</c:v>
                </c:pt>
                <c:pt idx="2">
                  <c:v>87.857763440569201</c:v>
                </c:pt>
                <c:pt idx="3">
                  <c:v>87.612440853348758</c:v>
                </c:pt>
                <c:pt idx="4">
                  <c:v>77.0910500512585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8B3-48BF-A904-C66505011843}"/>
            </c:ext>
          </c:extLst>
        </c:ser>
        <c:ser>
          <c:idx val="1"/>
          <c:order val="1"/>
          <c:tx>
            <c:strRef>
              <c:f>'UCN&amp;Caffeine MTT graph madefrom'!$N$27</c:f>
              <c:strCache>
                <c:ptCount val="1"/>
                <c:pt idx="0">
                  <c:v>TPC-1</c:v>
                </c:pt>
              </c:strCache>
            </c:strRef>
          </c:tx>
          <c:spPr>
            <a:ln w="28575" cmpd="sng"/>
          </c:spPr>
          <c:marker>
            <c:spPr>
              <a:ln w="28575" cmpd="sng"/>
            </c:spPr>
          </c:marker>
          <c:cat>
            <c:numRef>
              <c:f>'UCN&amp;Caffeine MTT graph madefrom'!$L$28:$L$32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.5</c:v>
                </c:pt>
                <c:pt idx="4">
                  <c:v>5</c:v>
                </c:pt>
              </c:numCache>
            </c:numRef>
          </c:cat>
          <c:val>
            <c:numRef>
              <c:f>'UCN&amp;Caffeine MTT graph madefrom'!$N$28:$N$32</c:f>
              <c:numCache>
                <c:formatCode>0</c:formatCode>
                <c:ptCount val="5"/>
                <c:pt idx="0">
                  <c:v>100</c:v>
                </c:pt>
                <c:pt idx="1">
                  <c:v>102.87657058257631</c:v>
                </c:pt>
                <c:pt idx="2">
                  <c:v>98.991442307310024</c:v>
                </c:pt>
                <c:pt idx="3">
                  <c:v>92.874994895122569</c:v>
                </c:pt>
                <c:pt idx="4">
                  <c:v>50.0257881453075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8B3-48BF-A904-C66505011843}"/>
            </c:ext>
          </c:extLst>
        </c:ser>
        <c:ser>
          <c:idx val="2"/>
          <c:order val="2"/>
          <c:tx>
            <c:strRef>
              <c:f>'UCN&amp;Caffeine MTT graph madefrom'!$O$27</c:f>
              <c:strCache>
                <c:ptCount val="1"/>
                <c:pt idx="0">
                  <c:v>Uhth74</c:v>
                </c:pt>
              </c:strCache>
            </c:strRef>
          </c:tx>
          <c:spPr>
            <a:ln w="28575" cmpd="sng"/>
          </c:spPr>
          <c:marker>
            <c:spPr>
              <a:ln w="28575" cmpd="sng"/>
            </c:spPr>
          </c:marker>
          <c:cat>
            <c:numRef>
              <c:f>'UCN&amp;Caffeine MTT graph madefrom'!$L$28:$L$32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.5</c:v>
                </c:pt>
                <c:pt idx="4">
                  <c:v>5</c:v>
                </c:pt>
              </c:numCache>
            </c:numRef>
          </c:cat>
          <c:val>
            <c:numRef>
              <c:f>'UCN&amp;Caffeine MTT graph madefrom'!$O$28:$O$32</c:f>
              <c:numCache>
                <c:formatCode>0</c:formatCode>
                <c:ptCount val="5"/>
                <c:pt idx="0">
                  <c:v>100</c:v>
                </c:pt>
                <c:pt idx="1">
                  <c:v>98.207097666765222</c:v>
                </c:pt>
                <c:pt idx="2">
                  <c:v>97.445678692586569</c:v>
                </c:pt>
                <c:pt idx="3">
                  <c:v>95.57395921048024</c:v>
                </c:pt>
                <c:pt idx="4">
                  <c:v>96.6552061064313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8B3-48BF-A904-C665050118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12979608"/>
        <c:axId val="2092367720"/>
      </c:lineChart>
      <c:catAx>
        <c:axId val="12129796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Caffeine (</a:t>
                </a:r>
                <a:r>
                  <a:rPr lang="en-US" dirty="0" err="1"/>
                  <a:t>mM</a:t>
                </a:r>
                <a:r>
                  <a:rPr lang="en-US" dirty="0"/>
                  <a:t>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2092367720"/>
        <c:crosses val="autoZero"/>
        <c:auto val="1"/>
        <c:lblAlgn val="ctr"/>
        <c:lblOffset val="100"/>
        <c:noMultiLvlLbl val="0"/>
      </c:catAx>
      <c:valAx>
        <c:axId val="20923677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MTS</a:t>
                </a:r>
                <a:r>
                  <a:rPr lang="en-US" baseline="0" dirty="0"/>
                  <a:t> </a:t>
                </a:r>
                <a:r>
                  <a:rPr lang="en-US" dirty="0"/>
                  <a:t>(% of control)</a:t>
                </a:r>
              </a:p>
            </c:rich>
          </c:tx>
          <c:layout>
            <c:manualLayout>
              <c:xMode val="edge"/>
              <c:yMode val="edge"/>
              <c:x val="2.7777777777777801E-3"/>
              <c:y val="0.28975247885680999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crossAx val="12129796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2315461097023903"/>
          <c:y val="4.9057183594041702E-2"/>
          <c:w val="0.26841819031095698"/>
          <c:h val="0.18065962383483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727587860538798"/>
          <c:y val="0.21277794671188399"/>
          <c:w val="0.73880727104035204"/>
          <c:h val="0.60506183847265205"/>
        </c:manualLayout>
      </c:layout>
      <c:lineChart>
        <c:grouping val="standard"/>
        <c:varyColors val="0"/>
        <c:ser>
          <c:idx val="0"/>
          <c:order val="0"/>
          <c:tx>
            <c:strRef>
              <c:f>'UCN&amp;Caffeine MTT graph madefrom'!$W$27</c:f>
              <c:strCache>
                <c:ptCount val="1"/>
                <c:pt idx="0">
                  <c:v>C643</c:v>
                </c:pt>
              </c:strCache>
            </c:strRef>
          </c:tx>
          <c:spPr>
            <a:ln w="28575" cmpd="sng"/>
          </c:spPr>
          <c:marker>
            <c:spPr>
              <a:ln w="28575" cmpd="sng"/>
            </c:spPr>
          </c:marker>
          <c:cat>
            <c:numRef>
              <c:f>'UCN&amp;Caffeine MTT graph madefrom'!$V$28:$V$32</c:f>
              <c:numCache>
                <c:formatCode>General</c:formatCode>
                <c:ptCount val="5"/>
                <c:pt idx="0" formatCode="0">
                  <c:v>0</c:v>
                </c:pt>
                <c:pt idx="1">
                  <c:v>10</c:v>
                </c:pt>
                <c:pt idx="2">
                  <c:v>25</c:v>
                </c:pt>
                <c:pt idx="3">
                  <c:v>50</c:v>
                </c:pt>
                <c:pt idx="4">
                  <c:v>100</c:v>
                </c:pt>
              </c:numCache>
            </c:numRef>
          </c:cat>
          <c:val>
            <c:numRef>
              <c:f>'UCN&amp;Caffeine MTT graph madefrom'!$W$28:$W$32</c:f>
              <c:numCache>
                <c:formatCode>0</c:formatCode>
                <c:ptCount val="5"/>
                <c:pt idx="0">
                  <c:v>100</c:v>
                </c:pt>
                <c:pt idx="1">
                  <c:v>101.3983908837138</c:v>
                </c:pt>
                <c:pt idx="2">
                  <c:v>92.021376885898448</c:v>
                </c:pt>
                <c:pt idx="3">
                  <c:v>88.50020037360126</c:v>
                </c:pt>
                <c:pt idx="4">
                  <c:v>61.5691232992710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E98-4FC1-92E8-4F8B43917EDB}"/>
            </c:ext>
          </c:extLst>
        </c:ser>
        <c:ser>
          <c:idx val="1"/>
          <c:order val="1"/>
          <c:tx>
            <c:strRef>
              <c:f>'UCN&amp;Caffeine MTT graph madefrom'!$X$27</c:f>
              <c:strCache>
                <c:ptCount val="1"/>
                <c:pt idx="0">
                  <c:v>TPC-1</c:v>
                </c:pt>
              </c:strCache>
            </c:strRef>
          </c:tx>
          <c:spPr>
            <a:ln w="28575" cmpd="sng"/>
          </c:spPr>
          <c:marker>
            <c:spPr>
              <a:ln w="28575" cmpd="sng"/>
            </c:spPr>
          </c:marker>
          <c:cat>
            <c:numRef>
              <c:f>'UCN&amp;Caffeine MTT graph madefrom'!$V$28:$V$32</c:f>
              <c:numCache>
                <c:formatCode>General</c:formatCode>
                <c:ptCount val="5"/>
                <c:pt idx="0" formatCode="0">
                  <c:v>0</c:v>
                </c:pt>
                <c:pt idx="1">
                  <c:v>10</c:v>
                </c:pt>
                <c:pt idx="2">
                  <c:v>25</c:v>
                </c:pt>
                <c:pt idx="3">
                  <c:v>50</c:v>
                </c:pt>
                <c:pt idx="4">
                  <c:v>100</c:v>
                </c:pt>
              </c:numCache>
            </c:numRef>
          </c:cat>
          <c:val>
            <c:numRef>
              <c:f>'UCN&amp;Caffeine MTT graph madefrom'!$X$28:$X$32</c:f>
              <c:numCache>
                <c:formatCode>0</c:formatCode>
                <c:ptCount val="5"/>
                <c:pt idx="0">
                  <c:v>100</c:v>
                </c:pt>
                <c:pt idx="1">
                  <c:v>91.668588918018955</c:v>
                </c:pt>
                <c:pt idx="2">
                  <c:v>87.418519282610404</c:v>
                </c:pt>
                <c:pt idx="3">
                  <c:v>86.638192796225752</c:v>
                </c:pt>
                <c:pt idx="4">
                  <c:v>42.9923903978407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E98-4FC1-92E8-4F8B43917EDB}"/>
            </c:ext>
          </c:extLst>
        </c:ser>
        <c:ser>
          <c:idx val="2"/>
          <c:order val="2"/>
          <c:tx>
            <c:strRef>
              <c:f>'UCN&amp;Caffeine MTT graph madefrom'!$Y$27</c:f>
              <c:strCache>
                <c:ptCount val="1"/>
                <c:pt idx="0">
                  <c:v>Uhth74</c:v>
                </c:pt>
              </c:strCache>
            </c:strRef>
          </c:tx>
          <c:spPr>
            <a:ln w="28575" cmpd="sng"/>
          </c:spPr>
          <c:marker>
            <c:spPr>
              <a:ln w="28575" cmpd="sng"/>
            </c:spPr>
          </c:marker>
          <c:cat>
            <c:numRef>
              <c:f>'UCN&amp;Caffeine MTT graph madefrom'!$V$28:$V$32</c:f>
              <c:numCache>
                <c:formatCode>General</c:formatCode>
                <c:ptCount val="5"/>
                <c:pt idx="0" formatCode="0">
                  <c:v>0</c:v>
                </c:pt>
                <c:pt idx="1">
                  <c:v>10</c:v>
                </c:pt>
                <c:pt idx="2">
                  <c:v>25</c:v>
                </c:pt>
                <c:pt idx="3">
                  <c:v>50</c:v>
                </c:pt>
                <c:pt idx="4">
                  <c:v>100</c:v>
                </c:pt>
              </c:numCache>
            </c:numRef>
          </c:cat>
          <c:val>
            <c:numRef>
              <c:f>'UCN&amp;Caffeine MTT graph madefrom'!$Y$28:$Y$32</c:f>
              <c:numCache>
                <c:formatCode>0</c:formatCode>
                <c:ptCount val="5"/>
                <c:pt idx="0">
                  <c:v>100</c:v>
                </c:pt>
                <c:pt idx="1">
                  <c:v>104.1208195877107</c:v>
                </c:pt>
                <c:pt idx="2">
                  <c:v>92.591669298586524</c:v>
                </c:pt>
                <c:pt idx="3">
                  <c:v>87.360314230963198</c:v>
                </c:pt>
                <c:pt idx="4">
                  <c:v>67.6407268434674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E98-4FC1-92E8-4F8B43917E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90443192"/>
        <c:axId val="1208721272"/>
      </c:lineChart>
      <c:catAx>
        <c:axId val="20904431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UCN-01</a:t>
                </a:r>
                <a:r>
                  <a:rPr lang="en-US" baseline="0" dirty="0"/>
                  <a:t> (</a:t>
                </a:r>
                <a:r>
                  <a:rPr lang="en-US" baseline="0" dirty="0" err="1"/>
                  <a:t>nM</a:t>
                </a:r>
                <a:r>
                  <a:rPr lang="en-US" baseline="0" dirty="0"/>
                  <a:t>)</a:t>
                </a:r>
                <a:endParaRPr lang="en-US" dirty="0"/>
              </a:p>
            </c:rich>
          </c:tx>
          <c:overlay val="0"/>
        </c:title>
        <c:numFmt formatCode="0" sourceLinked="1"/>
        <c:majorTickMark val="out"/>
        <c:minorTickMark val="none"/>
        <c:tickLblPos val="nextTo"/>
        <c:crossAx val="1208721272"/>
        <c:crosses val="autoZero"/>
        <c:auto val="1"/>
        <c:lblAlgn val="ctr"/>
        <c:lblOffset val="100"/>
        <c:noMultiLvlLbl val="0"/>
      </c:catAx>
      <c:valAx>
        <c:axId val="12087212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MTS (% of control)</a:t>
                </a:r>
              </a:p>
            </c:rich>
          </c:tx>
          <c:overlay val="0"/>
        </c:title>
        <c:numFmt formatCode="0" sourceLinked="1"/>
        <c:majorTickMark val="out"/>
        <c:minorTickMark val="none"/>
        <c:tickLblPos val="nextTo"/>
        <c:crossAx val="20904431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0418210045636098"/>
          <c:y val="9.2727644434365597E-2"/>
          <c:w val="0.28899062659644598"/>
          <c:h val="0.18152198748971399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EF095978-543F-420B-A291-7F0A46B02D94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B19FB55-5C79-4ECC-9657-258B5AE5BB11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356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7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FDC1F-45A7-42D4-B0AB-D0E80F74B5BD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2B647-9B54-45C9-9EA2-6F36B0F7591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FDC1F-45A7-42D4-B0AB-D0E80F74B5BD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2B647-9B54-45C9-9EA2-6F36B0F7591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81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FDC1F-45A7-42D4-B0AB-D0E80F74B5BD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2B647-9B54-45C9-9EA2-6F36B0F7591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FDC1F-45A7-42D4-B0AB-D0E80F74B5BD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2B647-9B54-45C9-9EA2-6F36B0F7591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FDC1F-45A7-42D4-B0AB-D0E80F74B5BD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2B647-9B54-45C9-9EA2-6F36B0F7591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FDC1F-45A7-42D4-B0AB-D0E80F74B5BD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2B647-9B54-45C9-9EA2-6F36B0F7591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6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6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FDC1F-45A7-42D4-B0AB-D0E80F74B5BD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2B647-9B54-45C9-9EA2-6F36B0F7591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FDC1F-45A7-42D4-B0AB-D0E80F74B5BD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2B647-9B54-45C9-9EA2-6F36B0F7591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FDC1F-45A7-42D4-B0AB-D0E80F74B5BD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2B647-9B54-45C9-9EA2-6F36B0F7591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7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4" y="364072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7" y="1913472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FDC1F-45A7-42D4-B0AB-D0E80F74B5BD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2B647-9B54-45C9-9EA2-6F36B0F7591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FDC1F-45A7-42D4-B0AB-D0E80F74B5BD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2B647-9B54-45C9-9EA2-6F36B0F7591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7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9FDC1F-45A7-42D4-B0AB-D0E80F74B5BD}" type="datetimeFigureOut">
              <a:rPr lang="en-US" smtClean="0"/>
              <a:pPr/>
              <a:t>8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02B647-9B54-45C9-9EA2-6F36B0F7591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emf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emf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openxmlformats.org/officeDocument/2006/relationships/image" Target="../media/image25.png"/><Relationship Id="rId3" Type="http://schemas.openxmlformats.org/officeDocument/2006/relationships/image" Target="../media/image15.emf"/><Relationship Id="rId7" Type="http://schemas.openxmlformats.org/officeDocument/2006/relationships/image" Target="../media/image19.png"/><Relationship Id="rId12" Type="http://schemas.openxmlformats.org/officeDocument/2006/relationships/image" Target="../media/image24.png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11" Type="http://schemas.openxmlformats.org/officeDocument/2006/relationships/image" Target="../media/image23.png"/><Relationship Id="rId5" Type="http://schemas.openxmlformats.org/officeDocument/2006/relationships/image" Target="../media/image17.png"/><Relationship Id="rId10" Type="http://schemas.openxmlformats.org/officeDocument/2006/relationships/image" Target="../media/image22.png"/><Relationship Id="rId4" Type="http://schemas.openxmlformats.org/officeDocument/2006/relationships/image" Target="../media/image16.emf"/><Relationship Id="rId9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13" Type="http://schemas.openxmlformats.org/officeDocument/2006/relationships/image" Target="../media/image34.png"/><Relationship Id="rId3" Type="http://schemas.openxmlformats.org/officeDocument/2006/relationships/image" Target="../media/image28.png"/><Relationship Id="rId7" Type="http://schemas.openxmlformats.org/officeDocument/2006/relationships/image" Target="../media/image32.emf"/><Relationship Id="rId12" Type="http://schemas.openxmlformats.org/officeDocument/2006/relationships/image" Target="../media/image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11" Type="http://schemas.openxmlformats.org/officeDocument/2006/relationships/image" Target="../media/image7.png"/><Relationship Id="rId5" Type="http://schemas.openxmlformats.org/officeDocument/2006/relationships/image" Target="../media/image30.png"/><Relationship Id="rId10" Type="http://schemas.openxmlformats.org/officeDocument/2006/relationships/image" Target="../media/image6.png"/><Relationship Id="rId4" Type="http://schemas.openxmlformats.org/officeDocument/2006/relationships/image" Target="../media/image29.png"/><Relationship Id="rId9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:\Users\Sathyanarayana N.S\AppData\Local\Microsoft\Windows\Temporary Internet Files\Content.Word\10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2" y="372534"/>
            <a:ext cx="5486398" cy="380642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0" y="1693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4250292"/>
            <a:ext cx="3140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9" name="ZoneTexte 23"/>
          <p:cNvSpPr txBox="1"/>
          <p:nvPr/>
        </p:nvSpPr>
        <p:spPr>
          <a:xfrm>
            <a:off x="5844130" y="8804304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itchFamily="34" charset="0"/>
                <a:cs typeface="Arial" pitchFamily="34" charset="0"/>
              </a:rPr>
              <a:t>Figure S1</a:t>
            </a:r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4883847"/>
              </p:ext>
            </p:extLst>
          </p:nvPr>
        </p:nvGraphicFramePr>
        <p:xfrm>
          <a:off x="355600" y="4555067"/>
          <a:ext cx="2997200" cy="2463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377504"/>
              </p:ext>
            </p:extLst>
          </p:nvPr>
        </p:nvGraphicFramePr>
        <p:xfrm>
          <a:off x="3615267" y="4597400"/>
          <a:ext cx="2895600" cy="23283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TextBox 6"/>
          <p:cNvSpPr txBox="1"/>
          <p:nvPr/>
        </p:nvSpPr>
        <p:spPr>
          <a:xfrm>
            <a:off x="3259663" y="4233358"/>
            <a:ext cx="306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2" name="Rectangle 1"/>
          <p:cNvSpPr/>
          <p:nvPr/>
        </p:nvSpPr>
        <p:spPr>
          <a:xfrm>
            <a:off x="220134" y="7234409"/>
            <a:ext cx="641773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1638300" algn="l"/>
              </a:tabLst>
            </a:pP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1. Response of thyroid cancer cell lines to </a:t>
            </a:r>
            <a:r>
              <a:rPr lang="en-US" sz="1200" b="1" dirty="0">
                <a:latin typeface="Symbol" charset="2"/>
                <a:ea typeface="Calibri" pitchFamily="34" charset="0"/>
                <a:cs typeface="Symbol" charset="2"/>
              </a:rPr>
              <a:t>g</a:t>
            </a: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-irradiation, caffeine and UCN-01 </a:t>
            </a: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tabLst>
                <a:tab pos="1638300" algn="l"/>
              </a:tabLst>
            </a:pP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. 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643, Uhth74 and TPC-1 cells were submitted to increasing doses of </a:t>
            </a:r>
            <a:r>
              <a:rPr lang="en-US" sz="1200" b="1" dirty="0">
                <a:latin typeface="Symbol" charset="2"/>
                <a:ea typeface="Calibri" pitchFamily="34" charset="0"/>
                <a:cs typeface="Symbol" charset="2"/>
              </a:rPr>
              <a:t>g-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adiation (1, 5 and 10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y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) and cultured for 24 hours. After fixation with chilled 70% ethanol, cells were treated with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Nase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 labeled with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ropidium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iodide and analyzed by flow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ytometry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</a:t>
            </a: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.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fter cell culture in presence of caffeine (0.5mM-5mM) for 24 hours, toxicity was evaluated with a MTS assay. The data are representative of three independent experiments.  </a:t>
            </a: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.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Upon culture in presence of UCN-01 (10 -100nM), cells were analyzed as described in B.</a:t>
            </a:r>
          </a:p>
        </p:txBody>
      </p:sp>
    </p:spTree>
    <p:extLst>
      <p:ext uri="{BB962C8B-B14F-4D97-AF65-F5344CB8AC3E}">
        <p14:creationId xmlns:p14="http://schemas.microsoft.com/office/powerpoint/2010/main" val="22573450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1581535"/>
              </p:ext>
            </p:extLst>
          </p:nvPr>
        </p:nvGraphicFramePr>
        <p:xfrm>
          <a:off x="3728495" y="2269066"/>
          <a:ext cx="2731562" cy="1041405"/>
        </p:xfrm>
        <a:graphic>
          <a:graphicData uri="http://schemas.openxmlformats.org/drawingml/2006/table">
            <a:tbl>
              <a:tblPr/>
              <a:tblGrid>
                <a:gridCol w="5442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99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07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765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7687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294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31589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Mock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err="1">
                          <a:latin typeface="Arial"/>
                          <a:ea typeface="Calibri"/>
                          <a:cs typeface="Times New Roman"/>
                        </a:rPr>
                        <a:t>Caff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UCN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IR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err="1">
                          <a:latin typeface="Arial"/>
                          <a:ea typeface="Calibri"/>
                          <a:cs typeface="Times New Roman"/>
                        </a:rPr>
                        <a:t>Dox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89962" y="118544"/>
            <a:ext cx="3770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251202" y="118548"/>
            <a:ext cx="3557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29" name="TextBox 23"/>
          <p:cNvSpPr txBox="1"/>
          <p:nvPr/>
        </p:nvSpPr>
        <p:spPr>
          <a:xfrm>
            <a:off x="174628" y="3437451"/>
            <a:ext cx="3698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33" name="TextBox 23"/>
          <p:cNvSpPr txBox="1"/>
          <p:nvPr/>
        </p:nvSpPr>
        <p:spPr>
          <a:xfrm>
            <a:off x="3251202" y="3437451"/>
            <a:ext cx="3698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35" name="ZoneTexte 23"/>
          <p:cNvSpPr txBox="1"/>
          <p:nvPr/>
        </p:nvSpPr>
        <p:spPr>
          <a:xfrm>
            <a:off x="5861063" y="8804304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itchFamily="34" charset="0"/>
                <a:cs typeface="Arial" pitchFamily="34" charset="0"/>
              </a:rPr>
              <a:t>Figure S2</a:t>
            </a: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2" cstate="print"/>
          <a:srcRect t="1" b="27971"/>
          <a:stretch/>
        </p:blipFill>
        <p:spPr>
          <a:xfrm>
            <a:off x="3818469" y="478232"/>
            <a:ext cx="2777066" cy="1723108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3" cstate="print"/>
          <a:srcRect t="8817" b="25400"/>
          <a:stretch/>
        </p:blipFill>
        <p:spPr>
          <a:xfrm>
            <a:off x="431800" y="3780628"/>
            <a:ext cx="2895600" cy="1841222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4" cstate="print"/>
          <a:srcRect t="12264" b="25569"/>
          <a:stretch/>
        </p:blipFill>
        <p:spPr>
          <a:xfrm>
            <a:off x="3674533" y="3823230"/>
            <a:ext cx="2870200" cy="1739362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653877" y="1291051"/>
            <a:ext cx="510309" cy="2570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Mock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573229" y="1295169"/>
            <a:ext cx="325177" cy="2570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IR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460166" y="1282928"/>
            <a:ext cx="431792" cy="2570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Dox</a:t>
            </a:r>
            <a:endParaRPr lang="en-US" sz="10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65357" y="2118069"/>
            <a:ext cx="445119" cy="2570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itchFamily="34" charset="0"/>
                <a:cs typeface="Arial" pitchFamily="34" charset="0"/>
              </a:rPr>
              <a:t>Caff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434590" y="2125335"/>
            <a:ext cx="658350" cy="2570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itchFamily="34" charset="0"/>
                <a:cs typeface="Arial" pitchFamily="34" charset="0"/>
              </a:rPr>
              <a:t>IR+Caff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329535" y="2125335"/>
            <a:ext cx="906792" cy="2570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itchFamily="34" charset="0"/>
                <a:cs typeface="Arial" pitchFamily="34" charset="0"/>
              </a:rPr>
              <a:t>Dox+Caff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36"/>
          <p:cNvSpPr txBox="1"/>
          <p:nvPr/>
        </p:nvSpPr>
        <p:spPr>
          <a:xfrm>
            <a:off x="627846" y="2968713"/>
            <a:ext cx="480637" cy="2570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UCN</a:t>
            </a:r>
          </a:p>
        </p:txBody>
      </p:sp>
      <p:sp>
        <p:nvSpPr>
          <p:cNvPr id="19" name="TextBox 36"/>
          <p:cNvSpPr txBox="1"/>
          <p:nvPr/>
        </p:nvSpPr>
        <p:spPr>
          <a:xfrm>
            <a:off x="1404496" y="2968714"/>
            <a:ext cx="691732" cy="2570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IR+UCN</a:t>
            </a:r>
          </a:p>
        </p:txBody>
      </p:sp>
      <p:sp>
        <p:nvSpPr>
          <p:cNvPr id="20" name="TextBox 36"/>
          <p:cNvSpPr txBox="1"/>
          <p:nvPr/>
        </p:nvSpPr>
        <p:spPr>
          <a:xfrm>
            <a:off x="2188743" y="2961448"/>
            <a:ext cx="973253" cy="2570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>
                <a:latin typeface="Arial" pitchFamily="34" charset="0"/>
                <a:cs typeface="Arial" pitchFamily="34" charset="0"/>
              </a:rPr>
              <a:t>Dox+UCN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6" name="Picture 10"/>
          <p:cNvPicPr preferRelativeResize="0">
            <a:picLocks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13" r="9418"/>
          <a:stretch/>
        </p:blipFill>
        <p:spPr bwMode="auto">
          <a:xfrm>
            <a:off x="524935" y="875734"/>
            <a:ext cx="788381" cy="4123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37" name="Picture 11"/>
          <p:cNvPicPr preferRelativeResize="0">
            <a:picLocks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46" r="49533"/>
          <a:stretch/>
        </p:blipFill>
        <p:spPr bwMode="auto">
          <a:xfrm>
            <a:off x="1341007" y="782144"/>
            <a:ext cx="892507" cy="512620"/>
          </a:xfrm>
          <a:prstGeom prst="rect">
            <a:avLst/>
          </a:prstGeom>
          <a:noFill/>
          <a:ln>
            <a:solidFill>
              <a:srgbClr val="FFFFFF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40" name="Picture 13"/>
          <p:cNvPicPr preferRelativeResize="0">
            <a:picLocks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40" r="24398"/>
          <a:stretch/>
        </p:blipFill>
        <p:spPr bwMode="auto">
          <a:xfrm>
            <a:off x="614184" y="1724443"/>
            <a:ext cx="580130" cy="426378"/>
          </a:xfrm>
          <a:prstGeom prst="rect">
            <a:avLst/>
          </a:prstGeom>
          <a:noFill/>
          <a:ln>
            <a:solidFill>
              <a:srgbClr val="FFFFFF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41" name="Picture 14"/>
          <p:cNvPicPr preferRelativeResize="0">
            <a:picLocks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39" r="20321"/>
          <a:stretch/>
        </p:blipFill>
        <p:spPr bwMode="auto">
          <a:xfrm>
            <a:off x="1447190" y="1696236"/>
            <a:ext cx="609881" cy="468274"/>
          </a:xfrm>
          <a:prstGeom prst="rect">
            <a:avLst/>
          </a:prstGeom>
          <a:noFill/>
          <a:ln>
            <a:solidFill>
              <a:srgbClr val="FFFFFF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43" name="Picture 8"/>
          <p:cNvPicPr preferRelativeResize="0">
            <a:picLocks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45" r="8791"/>
          <a:stretch/>
        </p:blipFill>
        <p:spPr bwMode="auto">
          <a:xfrm>
            <a:off x="569560" y="2544948"/>
            <a:ext cx="696806" cy="463242"/>
          </a:xfrm>
          <a:prstGeom prst="rect">
            <a:avLst/>
          </a:prstGeom>
          <a:noFill/>
          <a:ln>
            <a:solidFill>
              <a:srgbClr val="FFFFFF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44" name="Picture 7"/>
          <p:cNvPicPr preferRelativeResize="0">
            <a:picLocks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43" t="44586" r="17778" b="1"/>
          <a:stretch/>
        </p:blipFill>
        <p:spPr bwMode="auto">
          <a:xfrm>
            <a:off x="1376933" y="2503925"/>
            <a:ext cx="714006" cy="476913"/>
          </a:xfrm>
          <a:prstGeom prst="rect">
            <a:avLst/>
          </a:prstGeom>
          <a:noFill/>
          <a:ln>
            <a:solidFill>
              <a:srgbClr val="FFFFFF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11" cstate="print"/>
          <a:srcRect l="14072" r="44064"/>
          <a:stretch/>
        </p:blipFill>
        <p:spPr>
          <a:xfrm>
            <a:off x="2324824" y="850521"/>
            <a:ext cx="818132" cy="437602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12" cstate="print"/>
          <a:srcRect l="13427" t="37813" r="38798"/>
          <a:stretch/>
        </p:blipFill>
        <p:spPr>
          <a:xfrm>
            <a:off x="2280200" y="1630000"/>
            <a:ext cx="847883" cy="502556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13" cstate="print"/>
          <a:srcRect l="14815" t="43939" r="47138"/>
          <a:stretch/>
        </p:blipFill>
        <p:spPr>
          <a:xfrm>
            <a:off x="2235574" y="2490249"/>
            <a:ext cx="981759" cy="478628"/>
          </a:xfrm>
          <a:prstGeom prst="rect">
            <a:avLst/>
          </a:prstGeom>
        </p:spPr>
      </p:pic>
      <p:graphicFrame>
        <p:nvGraphicFramePr>
          <p:cNvPr id="38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1567374"/>
              </p:ext>
            </p:extLst>
          </p:nvPr>
        </p:nvGraphicFramePr>
        <p:xfrm>
          <a:off x="426496" y="5620649"/>
          <a:ext cx="2731562" cy="1059555"/>
        </p:xfrm>
        <a:graphic>
          <a:graphicData uri="http://schemas.openxmlformats.org/drawingml/2006/table">
            <a:tbl>
              <a:tblPr/>
              <a:tblGrid>
                <a:gridCol w="5442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99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07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765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7687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294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31589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2119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Mock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19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err="1">
                          <a:latin typeface="Arial"/>
                          <a:ea typeface="Calibri"/>
                          <a:cs typeface="Times New Roman"/>
                        </a:rPr>
                        <a:t>Caff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19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UCN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19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IR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19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err="1">
                          <a:latin typeface="Arial"/>
                          <a:ea typeface="Calibri"/>
                          <a:cs typeface="Times New Roman"/>
                        </a:rPr>
                        <a:t>Dox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aphicFrame>
        <p:nvGraphicFramePr>
          <p:cNvPr id="45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0078033"/>
              </p:ext>
            </p:extLst>
          </p:nvPr>
        </p:nvGraphicFramePr>
        <p:xfrm>
          <a:off x="3669223" y="5612178"/>
          <a:ext cx="2731562" cy="1059555"/>
        </p:xfrm>
        <a:graphic>
          <a:graphicData uri="http://schemas.openxmlformats.org/drawingml/2006/table">
            <a:tbl>
              <a:tblPr/>
              <a:tblGrid>
                <a:gridCol w="5442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99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07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765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7687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294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31589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2119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Mock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19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err="1">
                          <a:latin typeface="Arial"/>
                          <a:ea typeface="Calibri"/>
                          <a:cs typeface="Times New Roman"/>
                        </a:rPr>
                        <a:t>Caff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19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UCN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19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IR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191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err="1">
                          <a:latin typeface="Arial"/>
                          <a:ea typeface="Calibri"/>
                          <a:cs typeface="Times New Roman"/>
                        </a:rPr>
                        <a:t>Dox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245533" y="7021486"/>
            <a:ext cx="639233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-857250" algn="l"/>
              </a:tabLst>
            </a:pP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2. Inhibitors of cell cycle checkpoints abrogate G2/M arrest in TPC-1 cells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  <a:tabLst>
                <a:tab pos="-857250" algn="l"/>
              </a:tabLst>
            </a:pP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. 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PC-1 cells were </a:t>
            </a:r>
            <a:r>
              <a:rPr lang="en-US" sz="1200" dirty="0">
                <a:latin typeface="Symbol" charset="2"/>
                <a:ea typeface="Calibri" pitchFamily="34" charset="0"/>
                <a:cs typeface="Symbol" charset="2"/>
              </a:rPr>
              <a:t>g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-irradiated with 10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y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/or cultivated with caffeine (2.5mM) or UCN-01 (50nM). After 24 hours, cells were fixed with chilled 70% ethanol, labeled with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ropidium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iodide and analyzed by flow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ytometry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e percentages of cells in G2/M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, sub-G1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, and in polyploidy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 were calculated from three independent experiments. **: p &lt;0.01; ***: p &lt;0.001; ns (not significant) according to the one-way analysis of variance (ANOVA) test followed by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ukey'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Multiple Comparison.</a:t>
            </a:r>
          </a:p>
        </p:txBody>
      </p:sp>
    </p:spTree>
    <p:extLst>
      <p:ext uri="{BB962C8B-B14F-4D97-AF65-F5344CB8AC3E}">
        <p14:creationId xmlns:p14="http://schemas.microsoft.com/office/powerpoint/2010/main" val="25659578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TextBox 121"/>
          <p:cNvSpPr txBox="1"/>
          <p:nvPr/>
        </p:nvSpPr>
        <p:spPr>
          <a:xfrm>
            <a:off x="89962" y="237075"/>
            <a:ext cx="3770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3387915" y="270945"/>
            <a:ext cx="3557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24" name="TextBox 23"/>
          <p:cNvSpPr txBox="1"/>
          <p:nvPr/>
        </p:nvSpPr>
        <p:spPr>
          <a:xfrm>
            <a:off x="89962" y="3975111"/>
            <a:ext cx="3698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125" name="TextBox 23"/>
          <p:cNvSpPr txBox="1"/>
          <p:nvPr/>
        </p:nvSpPr>
        <p:spPr>
          <a:xfrm>
            <a:off x="3380839" y="3975111"/>
            <a:ext cx="3698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26" name="ZoneTexte 23"/>
          <p:cNvSpPr txBox="1"/>
          <p:nvPr/>
        </p:nvSpPr>
        <p:spPr>
          <a:xfrm>
            <a:off x="5861063" y="8804304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itchFamily="34" charset="0"/>
                <a:cs typeface="Arial" pitchFamily="34" charset="0"/>
              </a:rPr>
              <a:t>Figure S3</a:t>
            </a:r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2" cstate="print"/>
          <a:srcRect t="12205" b="25328"/>
          <a:stretch/>
        </p:blipFill>
        <p:spPr>
          <a:xfrm>
            <a:off x="402167" y="4483099"/>
            <a:ext cx="2914804" cy="1528235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3" cstate="print"/>
          <a:srcRect t="12253" b="25033"/>
          <a:stretch/>
        </p:blipFill>
        <p:spPr>
          <a:xfrm>
            <a:off x="3826937" y="821258"/>
            <a:ext cx="2877990" cy="1710267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4" cstate="print"/>
          <a:srcRect b="23963"/>
          <a:stretch/>
        </p:blipFill>
        <p:spPr>
          <a:xfrm>
            <a:off x="3742264" y="4368800"/>
            <a:ext cx="2840896" cy="1604429"/>
          </a:xfrm>
          <a:prstGeom prst="rect">
            <a:avLst/>
          </a:prstGeom>
        </p:spPr>
      </p:pic>
      <p:grpSp>
        <p:nvGrpSpPr>
          <p:cNvPr id="2" name="Grouper 1"/>
          <p:cNvGrpSpPr/>
          <p:nvPr/>
        </p:nvGrpSpPr>
        <p:grpSpPr>
          <a:xfrm>
            <a:off x="372534" y="845927"/>
            <a:ext cx="2853265" cy="2913273"/>
            <a:chOff x="228601" y="897467"/>
            <a:chExt cx="3073399" cy="3213513"/>
          </a:xfrm>
        </p:grpSpPr>
        <p:grpSp>
          <p:nvGrpSpPr>
            <p:cNvPr id="6" name="Group 5"/>
            <p:cNvGrpSpPr/>
            <p:nvPr/>
          </p:nvGrpSpPr>
          <p:grpSpPr>
            <a:xfrm>
              <a:off x="228601" y="897467"/>
              <a:ext cx="1854199" cy="3213512"/>
              <a:chOff x="1312333" y="3036643"/>
              <a:chExt cx="1950525" cy="3993768"/>
            </a:xfrm>
          </p:grpSpPr>
          <p:pic>
            <p:nvPicPr>
              <p:cNvPr id="83" name="Picture 4"/>
              <p:cNvPicPr preferRelativeResize="0">
                <a:picLocks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43"/>
              <a:stretch/>
            </p:blipFill>
            <p:spPr bwMode="auto">
              <a:xfrm>
                <a:off x="1354666" y="4541272"/>
                <a:ext cx="851010" cy="702985"/>
              </a:xfrm>
              <a:prstGeom prst="rect">
                <a:avLst/>
              </a:prstGeom>
              <a:noFill/>
              <a:ln>
                <a:solidFill>
                  <a:srgbClr val="FFFFFF"/>
                </a:solidFill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84" name="Picture 7"/>
              <p:cNvPicPr preferRelativeResize="0">
                <a:picLocks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12333" y="3230523"/>
                <a:ext cx="978425" cy="7792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85" name="Picture 9"/>
              <p:cNvPicPr preferRelativeResize="0">
                <a:picLocks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062" r="14008"/>
              <a:stretch/>
            </p:blipFill>
            <p:spPr bwMode="auto">
              <a:xfrm>
                <a:off x="1354665" y="5943601"/>
                <a:ext cx="795868" cy="660400"/>
              </a:xfrm>
              <a:prstGeom prst="rect">
                <a:avLst/>
              </a:prstGeom>
              <a:noFill/>
              <a:ln>
                <a:solidFill>
                  <a:srgbClr val="FFFFFF"/>
                </a:solidFill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86" name="Picture 11"/>
              <p:cNvPicPr preferRelativeResize="0">
                <a:picLocks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300" r="9625"/>
              <a:stretch/>
            </p:blipFill>
            <p:spPr bwMode="auto">
              <a:xfrm>
                <a:off x="2280196" y="5583025"/>
                <a:ext cx="982134" cy="1019388"/>
              </a:xfrm>
              <a:prstGeom prst="rect">
                <a:avLst/>
              </a:prstGeom>
              <a:noFill/>
              <a:ln>
                <a:solidFill>
                  <a:srgbClr val="FFFFFF"/>
                </a:solidFill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87" name="Picture 5"/>
              <p:cNvPicPr preferRelativeResize="0">
                <a:picLocks noChangeArrowheads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552" r="13793"/>
              <a:stretch/>
            </p:blipFill>
            <p:spPr bwMode="auto">
              <a:xfrm>
                <a:off x="2382324" y="4741274"/>
                <a:ext cx="795866" cy="525003"/>
              </a:xfrm>
              <a:prstGeom prst="rect">
                <a:avLst/>
              </a:prstGeom>
              <a:noFill/>
              <a:ln>
                <a:solidFill>
                  <a:srgbClr val="FFFFFF"/>
                </a:solidFill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88" name="Picture 6"/>
              <p:cNvPicPr preferRelativeResize="0">
                <a:picLocks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356925" y="3036643"/>
                <a:ext cx="905933" cy="996879"/>
              </a:xfrm>
              <a:prstGeom prst="rect">
                <a:avLst/>
              </a:prstGeom>
              <a:noFill/>
              <a:ln>
                <a:solidFill>
                  <a:srgbClr val="FFFFFF"/>
                </a:solidFill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</a:extLst>
            </p:spPr>
          </p:pic>
          <p:grpSp>
            <p:nvGrpSpPr>
              <p:cNvPr id="60" name="Group 59"/>
              <p:cNvGrpSpPr/>
              <p:nvPr/>
            </p:nvGrpSpPr>
            <p:grpSpPr>
              <a:xfrm>
                <a:off x="1359271" y="4071709"/>
                <a:ext cx="1795385" cy="2958702"/>
                <a:chOff x="1192690" y="5226895"/>
                <a:chExt cx="536927" cy="1924644"/>
              </a:xfrm>
            </p:grpSpPr>
            <p:sp>
              <p:nvSpPr>
                <p:cNvPr id="91" name="TextBox 90"/>
                <p:cNvSpPr txBox="1"/>
                <p:nvPr/>
              </p:nvSpPr>
              <p:spPr>
                <a:xfrm>
                  <a:off x="1212848" y="5226895"/>
                  <a:ext cx="184465" cy="2430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Mock</a:t>
                  </a:r>
                </a:p>
              </p:txBody>
            </p:sp>
            <p:sp>
              <p:nvSpPr>
                <p:cNvPr id="92" name="TextBox 91"/>
                <p:cNvSpPr txBox="1"/>
                <p:nvPr/>
              </p:nvSpPr>
              <p:spPr>
                <a:xfrm>
                  <a:off x="1545561" y="5226896"/>
                  <a:ext cx="117544" cy="2430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IR</a:t>
                  </a:r>
                </a:p>
              </p:txBody>
            </p:sp>
            <p:sp>
              <p:nvSpPr>
                <p:cNvPr id="94" name="TextBox 93"/>
                <p:cNvSpPr txBox="1"/>
                <p:nvPr/>
              </p:nvSpPr>
              <p:spPr>
                <a:xfrm>
                  <a:off x="1192690" y="5991230"/>
                  <a:ext cx="160900" cy="2430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dirty="0" err="1">
                      <a:latin typeface="Arial" pitchFamily="34" charset="0"/>
                      <a:cs typeface="Arial" pitchFamily="34" charset="0"/>
                    </a:rPr>
                    <a:t>Caff</a:t>
                  </a:r>
                  <a:endParaRPr lang="en-US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5" name="TextBox 94"/>
                <p:cNvSpPr txBox="1"/>
                <p:nvPr/>
              </p:nvSpPr>
              <p:spPr>
                <a:xfrm>
                  <a:off x="1485345" y="5991230"/>
                  <a:ext cx="237978" cy="2430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dirty="0" err="1">
                      <a:latin typeface="Arial" pitchFamily="34" charset="0"/>
                      <a:cs typeface="Arial" pitchFamily="34" charset="0"/>
                    </a:rPr>
                    <a:t>IR+Caff</a:t>
                  </a:r>
                  <a:endParaRPr lang="en-US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7" name="TextBox 36"/>
                <p:cNvSpPr txBox="1"/>
                <p:nvPr/>
              </p:nvSpPr>
              <p:spPr>
                <a:xfrm>
                  <a:off x="1209647" y="6908441"/>
                  <a:ext cx="173739" cy="2430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UCN</a:t>
                  </a:r>
                </a:p>
              </p:txBody>
            </p:sp>
            <p:sp>
              <p:nvSpPr>
                <p:cNvPr id="98" name="TextBox 36"/>
                <p:cNvSpPr txBox="1"/>
                <p:nvPr/>
              </p:nvSpPr>
              <p:spPr>
                <a:xfrm>
                  <a:off x="1479572" y="6908441"/>
                  <a:ext cx="250045" cy="2430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itchFamily="34" charset="0"/>
                      <a:cs typeface="Arial" pitchFamily="34" charset="0"/>
                    </a:rPr>
                    <a:t>IR+UCN</a:t>
                  </a:r>
                </a:p>
              </p:txBody>
            </p:sp>
          </p:grpSp>
        </p:grpSp>
        <p:pic>
          <p:nvPicPr>
            <p:cNvPr id="44" name="Picture 43"/>
            <p:cNvPicPr>
              <a:picLocks noChangeAspect="1"/>
            </p:cNvPicPr>
            <p:nvPr/>
          </p:nvPicPr>
          <p:blipFill rotWithShape="1">
            <a:blip r:embed="rId11" cstate="print"/>
            <a:srcRect l="11088" t="33987" r="48465"/>
            <a:stretch/>
          </p:blipFill>
          <p:spPr>
            <a:xfrm>
              <a:off x="2319867" y="2235200"/>
              <a:ext cx="982133" cy="461433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>
              <a:off x="2357850" y="2675750"/>
              <a:ext cx="878960" cy="300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err="1">
                  <a:latin typeface="Arial" pitchFamily="34" charset="0"/>
                  <a:cs typeface="Arial" pitchFamily="34" charset="0"/>
                </a:rPr>
                <a:t>Dox+Caff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46" name="Picture 45"/>
            <p:cNvPicPr>
              <a:picLocks noChangeAspect="1"/>
            </p:cNvPicPr>
            <p:nvPr/>
          </p:nvPicPr>
          <p:blipFill rotWithShape="1">
            <a:blip r:embed="rId12" cstate="print"/>
            <a:srcRect l="10808" t="46013" r="46235"/>
            <a:stretch/>
          </p:blipFill>
          <p:spPr>
            <a:xfrm>
              <a:off x="2286001" y="3200400"/>
              <a:ext cx="982133" cy="563032"/>
            </a:xfrm>
            <a:prstGeom prst="rect">
              <a:avLst/>
            </a:prstGeom>
          </p:spPr>
        </p:pic>
        <p:sp>
          <p:nvSpPr>
            <p:cNvPr id="47" name="TextBox 46"/>
            <p:cNvSpPr txBox="1"/>
            <p:nvPr/>
          </p:nvSpPr>
          <p:spPr>
            <a:xfrm>
              <a:off x="2313286" y="3810283"/>
              <a:ext cx="913997" cy="300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err="1">
                  <a:latin typeface="Arial" pitchFamily="34" charset="0"/>
                  <a:cs typeface="Arial" pitchFamily="34" charset="0"/>
                </a:rPr>
                <a:t>Dox+UCN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13" cstate="print"/>
            <a:srcRect l="11249" t="42262" r="45696"/>
            <a:stretch/>
          </p:blipFill>
          <p:spPr>
            <a:xfrm>
              <a:off x="2319868" y="1301750"/>
              <a:ext cx="948266" cy="408516"/>
            </a:xfrm>
            <a:prstGeom prst="rect">
              <a:avLst/>
            </a:prstGeom>
          </p:spPr>
        </p:pic>
        <p:sp>
          <p:nvSpPr>
            <p:cNvPr id="49" name="TextBox 48"/>
            <p:cNvSpPr txBox="1"/>
            <p:nvPr/>
          </p:nvSpPr>
          <p:spPr>
            <a:xfrm>
              <a:off x="2492134" y="1730318"/>
              <a:ext cx="496137" cy="300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err="1">
                  <a:latin typeface="Arial" pitchFamily="34" charset="0"/>
                  <a:cs typeface="Arial" pitchFamily="34" charset="0"/>
                </a:rPr>
                <a:t>Dox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8" name="Rectangle 37"/>
          <p:cNvSpPr/>
          <p:nvPr/>
        </p:nvSpPr>
        <p:spPr>
          <a:xfrm>
            <a:off x="296333" y="7436353"/>
            <a:ext cx="639233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-857250" algn="l"/>
              </a:tabLst>
            </a:pP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3. Inhibitors of cell cycle checkpoints abrogate G2/M arrest in Uhth74 cells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  <a:tabLst>
                <a:tab pos="-857250" algn="l"/>
              </a:tabLst>
            </a:pP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(A) 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hth74 cells were </a:t>
            </a:r>
            <a:r>
              <a:rPr lang="en-US" sz="1200" dirty="0">
                <a:latin typeface="Symbol" charset="2"/>
                <a:ea typeface="Calibri" pitchFamily="34" charset="0"/>
                <a:cs typeface="Symbol" charset="2"/>
              </a:rPr>
              <a:t>g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-irradiated with 10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y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/or cultivated with caffeine (2.5mM) or UCN-01 (50nM). After 24 hours, cells were fixed with chilled 70% ethanol, labeled with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ropidium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iodide and analyzed by flow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ytometry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e percentages of cells in G2/M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, sub-G1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, and in polyploidy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 were calculated from three independent experiments. **: p &lt;0.01; ***: p &lt;0.001 according to the one-way analysis of variance (ANOVA) test followed by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ukey'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Multiple Comparison.</a:t>
            </a:r>
          </a:p>
        </p:txBody>
      </p:sp>
      <p:graphicFrame>
        <p:nvGraphicFramePr>
          <p:cNvPr id="39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2255122"/>
              </p:ext>
            </p:extLst>
          </p:nvPr>
        </p:nvGraphicFramePr>
        <p:xfrm>
          <a:off x="3830092" y="2607725"/>
          <a:ext cx="2731562" cy="1041405"/>
        </p:xfrm>
        <a:graphic>
          <a:graphicData uri="http://schemas.openxmlformats.org/drawingml/2006/table">
            <a:tbl>
              <a:tblPr/>
              <a:tblGrid>
                <a:gridCol w="5442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99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07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765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7687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294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31589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Mock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err="1">
                          <a:latin typeface="Arial"/>
                          <a:ea typeface="Calibri"/>
                          <a:cs typeface="Times New Roman"/>
                        </a:rPr>
                        <a:t>Caff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UCN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IR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err="1">
                          <a:latin typeface="Arial"/>
                          <a:ea typeface="Calibri"/>
                          <a:cs typeface="Times New Roman"/>
                        </a:rPr>
                        <a:t>Dox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aphicFrame>
        <p:nvGraphicFramePr>
          <p:cNvPr id="40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9034868"/>
              </p:ext>
            </p:extLst>
          </p:nvPr>
        </p:nvGraphicFramePr>
        <p:xfrm>
          <a:off x="426492" y="6062125"/>
          <a:ext cx="2731562" cy="1041405"/>
        </p:xfrm>
        <a:graphic>
          <a:graphicData uri="http://schemas.openxmlformats.org/drawingml/2006/table">
            <a:tbl>
              <a:tblPr/>
              <a:tblGrid>
                <a:gridCol w="5442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99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07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765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7687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294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31589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Mock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err="1">
                          <a:latin typeface="Arial"/>
                          <a:ea typeface="Calibri"/>
                          <a:cs typeface="Times New Roman"/>
                        </a:rPr>
                        <a:t>Caff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UCN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IR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err="1">
                          <a:latin typeface="Arial"/>
                          <a:ea typeface="Calibri"/>
                          <a:cs typeface="Times New Roman"/>
                        </a:rPr>
                        <a:t>Dox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aphicFrame>
        <p:nvGraphicFramePr>
          <p:cNvPr id="51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5358397"/>
              </p:ext>
            </p:extLst>
          </p:nvPr>
        </p:nvGraphicFramePr>
        <p:xfrm>
          <a:off x="3715792" y="6062125"/>
          <a:ext cx="2731562" cy="1041405"/>
        </p:xfrm>
        <a:graphic>
          <a:graphicData uri="http://schemas.openxmlformats.org/drawingml/2006/table">
            <a:tbl>
              <a:tblPr/>
              <a:tblGrid>
                <a:gridCol w="5442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99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07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765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7687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4918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294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31589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Mock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err="1">
                          <a:latin typeface="Arial"/>
                          <a:ea typeface="Calibri"/>
                          <a:cs typeface="Times New Roman"/>
                        </a:rPr>
                        <a:t>Caff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UCN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IR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828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err="1">
                          <a:latin typeface="Arial"/>
                          <a:ea typeface="Calibri"/>
                          <a:cs typeface="Times New Roman"/>
                        </a:rPr>
                        <a:t>Dox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090958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8194540"/>
              </p:ext>
            </p:extLst>
          </p:nvPr>
        </p:nvGraphicFramePr>
        <p:xfrm>
          <a:off x="1590673" y="4525413"/>
          <a:ext cx="3115726" cy="1534370"/>
        </p:xfrm>
        <a:graphic>
          <a:graphicData uri="http://schemas.openxmlformats.org/drawingml/2006/table">
            <a:tbl>
              <a:tblPr/>
              <a:tblGrid>
                <a:gridCol w="73700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6416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641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416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6416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6416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6544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6416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6416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6416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30687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latin typeface="Arial"/>
                          <a:ea typeface="Calibri"/>
                          <a:cs typeface="Times New Roman"/>
                        </a:rPr>
                        <a:t>Mock</a:t>
                      </a:r>
                      <a:endParaRPr lang="en-US" sz="1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687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 err="1">
                          <a:latin typeface="Arial"/>
                          <a:ea typeface="Calibri"/>
                          <a:cs typeface="Times New Roman"/>
                        </a:rPr>
                        <a:t>Caff</a:t>
                      </a:r>
                      <a:endParaRPr lang="en-US" sz="1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687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latin typeface="Arial"/>
                          <a:ea typeface="Calibri"/>
                          <a:cs typeface="Times New Roman"/>
                        </a:rPr>
                        <a:t>UCN</a:t>
                      </a:r>
                      <a:endParaRPr lang="en-US" sz="1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0687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latin typeface="Arial"/>
                          <a:ea typeface="Calibri"/>
                          <a:cs typeface="Times New Roman"/>
                        </a:rPr>
                        <a:t>IR</a:t>
                      </a:r>
                      <a:endParaRPr lang="en-US" sz="1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0687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 err="1">
                          <a:latin typeface="Arial"/>
                          <a:ea typeface="Calibri"/>
                          <a:cs typeface="Times New Roman"/>
                        </a:rPr>
                        <a:t>Dox</a:t>
                      </a:r>
                      <a:endParaRPr lang="en-US" sz="1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-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+ </a:t>
                      </a:r>
                      <a:endParaRPr lang="en-US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pic>
        <p:nvPicPr>
          <p:cNvPr id="3" name="Picture 40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709199" y="2419109"/>
            <a:ext cx="3059112" cy="2048933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48625" y="7515866"/>
            <a:ext cx="639233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-857250" algn="l"/>
              </a:tabLst>
            </a:pP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4. Inhibitors of cell cycle checkpoints did not affect polyploidy in C643 cells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  <a:tabLst>
                <a:tab pos="-857250" algn="l"/>
              </a:tabLst>
            </a:pP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643 cells were </a:t>
            </a:r>
            <a:r>
              <a:rPr lang="en-US" sz="1200" dirty="0">
                <a:latin typeface="Symbol" charset="2"/>
                <a:ea typeface="Calibri" pitchFamily="34" charset="0"/>
                <a:cs typeface="Symbol" charset="2"/>
              </a:rPr>
              <a:t>g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-irradiated with 10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y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/or cultivated with caffeine (2.5mM) or UCN-01 (50nM). After 24 hours, cells were fixed with chilled 70% ethanol, labeled with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ropidium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iodide and analyzed by flow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ytometry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e percentages of polyploidy (&gt;G2/M)  was determined and in polyploidy were calculated from three independent experiments. **: p &lt;0.01; ***: p &lt;0.001 according to the one-way analysis of variance (ANOVA) test followed by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ukey'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Multiple Comparison.</a:t>
            </a:r>
          </a:p>
        </p:txBody>
      </p:sp>
      <p:sp>
        <p:nvSpPr>
          <p:cNvPr id="5" name="ZoneTexte 23"/>
          <p:cNvSpPr txBox="1"/>
          <p:nvPr/>
        </p:nvSpPr>
        <p:spPr>
          <a:xfrm>
            <a:off x="5861063" y="8804304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itchFamily="34" charset="0"/>
                <a:cs typeface="Arial" pitchFamily="34" charset="0"/>
              </a:rPr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28777295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ZoneTexte 23"/>
          <p:cNvSpPr txBox="1"/>
          <p:nvPr/>
        </p:nvSpPr>
        <p:spPr>
          <a:xfrm>
            <a:off x="5822962" y="8804304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itchFamily="34" charset="0"/>
                <a:cs typeface="Arial" pitchFamily="34" charset="0"/>
              </a:rPr>
              <a:t>Figure S5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0800" y="173554"/>
            <a:ext cx="3770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057525" y="211654"/>
            <a:ext cx="3557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grpSp>
        <p:nvGrpSpPr>
          <p:cNvPr id="98" name="Group 97"/>
          <p:cNvGrpSpPr/>
          <p:nvPr/>
        </p:nvGrpSpPr>
        <p:grpSpPr>
          <a:xfrm>
            <a:off x="609600" y="768335"/>
            <a:ext cx="2611637" cy="5476875"/>
            <a:chOff x="171450" y="323850"/>
            <a:chExt cx="2783087" cy="5476875"/>
          </a:xfrm>
        </p:grpSpPr>
        <p:sp>
          <p:nvSpPr>
            <p:cNvPr id="71" name="TextBox 70"/>
            <p:cNvSpPr txBox="1"/>
            <p:nvPr/>
          </p:nvSpPr>
          <p:spPr>
            <a:xfrm>
              <a:off x="1240309" y="1512110"/>
              <a:ext cx="3200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dirty="0">
                  <a:latin typeface="Arial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1254073" y="3191330"/>
              <a:ext cx="4263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dirty="0">
                  <a:latin typeface="Arial" pitchFamily="34" charset="0"/>
                  <a:cs typeface="Arial" pitchFamily="34" charset="0"/>
                </a:rPr>
                <a:t>21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320902" y="4101645"/>
              <a:ext cx="2001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dirty="0"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452332" y="4923715"/>
              <a:ext cx="4175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dirty="0">
                  <a:latin typeface="Arial" pitchFamily="34" charset="0"/>
                  <a:cs typeface="Arial" pitchFamily="34" charset="0"/>
                </a:rPr>
                <a:t>20</a:t>
              </a:r>
            </a:p>
          </p:txBody>
        </p:sp>
        <p:cxnSp>
          <p:nvCxnSpPr>
            <p:cNvPr id="35" name="Straight Arrow Connector 34"/>
            <p:cNvCxnSpPr/>
            <p:nvPr/>
          </p:nvCxnSpPr>
          <p:spPr>
            <a:xfrm flipV="1">
              <a:off x="171928" y="323850"/>
              <a:ext cx="0" cy="544804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/>
            <p:cNvCxnSpPr/>
            <p:nvPr/>
          </p:nvCxnSpPr>
          <p:spPr>
            <a:xfrm>
              <a:off x="171450" y="5786312"/>
              <a:ext cx="2783087" cy="1441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7" name="Group 65"/>
            <p:cNvGrpSpPr/>
            <p:nvPr/>
          </p:nvGrpSpPr>
          <p:grpSpPr>
            <a:xfrm>
              <a:off x="421499" y="2139918"/>
              <a:ext cx="1129361" cy="472920"/>
              <a:chOff x="604745" y="2781374"/>
              <a:chExt cx="1615928" cy="625078"/>
            </a:xfrm>
          </p:grpSpPr>
          <p:sp>
            <p:nvSpPr>
              <p:cNvPr id="46" name="TextBox 45"/>
              <p:cNvSpPr txBox="1"/>
              <p:nvPr/>
            </p:nvSpPr>
            <p:spPr>
              <a:xfrm>
                <a:off x="1762789" y="2999651"/>
                <a:ext cx="457884" cy="4068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400" dirty="0">
                    <a:latin typeface="Arial" pitchFamily="34" charset="0"/>
                    <a:cs typeface="Arial" pitchFamily="34" charset="0"/>
                  </a:rPr>
                  <a:t>2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604745" y="2781374"/>
                <a:ext cx="555324" cy="4068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itchFamily="34" charset="0"/>
                    <a:cs typeface="Arial" pitchFamily="34" charset="0"/>
                  </a:rPr>
                  <a:t>IR</a:t>
                </a:r>
              </a:p>
            </p:txBody>
          </p:sp>
        </p:grpSp>
      </p:grpSp>
      <p:sp>
        <p:nvSpPr>
          <p:cNvPr id="78" name="TextBox 77"/>
          <p:cNvSpPr txBox="1"/>
          <p:nvPr/>
        </p:nvSpPr>
        <p:spPr>
          <a:xfrm>
            <a:off x="1214913" y="6244126"/>
            <a:ext cx="12311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400" dirty="0">
                <a:latin typeface="Arial" pitchFamily="34" charset="0"/>
                <a:cs typeface="Arial" pitchFamily="34" charset="0"/>
              </a:rPr>
              <a:t>DNA Content</a:t>
            </a:r>
          </a:p>
        </p:txBody>
      </p:sp>
      <p:sp>
        <p:nvSpPr>
          <p:cNvPr id="79" name="TextBox 78"/>
          <p:cNvSpPr txBox="1"/>
          <p:nvPr/>
        </p:nvSpPr>
        <p:spPr>
          <a:xfrm rot="16200000">
            <a:off x="-519504" y="2997481"/>
            <a:ext cx="18069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400" dirty="0" err="1">
                <a:latin typeface="Arial" pitchFamily="34" charset="0"/>
                <a:cs typeface="Arial" pitchFamily="34" charset="0"/>
              </a:rPr>
              <a:t>Phospho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-histone H3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723900" y="815960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noFill/>
                <a:latin typeface="Arial" pitchFamily="34" charset="0"/>
                <a:cs typeface="Arial" pitchFamily="34" charset="0"/>
              </a:rPr>
              <a:t>Mock</a:t>
            </a:r>
          </a:p>
        </p:txBody>
      </p:sp>
      <p:sp>
        <p:nvSpPr>
          <p:cNvPr id="81" name="Rectangle 80"/>
          <p:cNvSpPr/>
          <p:nvPr/>
        </p:nvSpPr>
        <p:spPr>
          <a:xfrm>
            <a:off x="847725" y="2863835"/>
            <a:ext cx="142875" cy="2381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bg1"/>
              </a:solidFill>
            </a:endParaRPr>
          </a:p>
        </p:txBody>
      </p:sp>
      <p:grpSp>
        <p:nvGrpSpPr>
          <p:cNvPr id="99" name="Group 98"/>
          <p:cNvGrpSpPr/>
          <p:nvPr/>
        </p:nvGrpSpPr>
        <p:grpSpPr>
          <a:xfrm>
            <a:off x="720725" y="3463910"/>
            <a:ext cx="602409" cy="523875"/>
            <a:chOff x="720725" y="3095625"/>
            <a:chExt cx="602409" cy="523875"/>
          </a:xfrm>
        </p:grpSpPr>
        <p:sp>
          <p:nvSpPr>
            <p:cNvPr id="84" name="TextBox 83"/>
            <p:cNvSpPr txBox="1"/>
            <p:nvPr/>
          </p:nvSpPr>
          <p:spPr>
            <a:xfrm>
              <a:off x="720725" y="3095625"/>
              <a:ext cx="6024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>
                  <a:latin typeface="Arial" pitchFamily="34" charset="0"/>
                  <a:cs typeface="Arial" pitchFamily="34" charset="0"/>
                </a:rPr>
                <a:t>Taxol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Rectangle 88"/>
            <p:cNvSpPr/>
            <p:nvPr/>
          </p:nvSpPr>
          <p:spPr>
            <a:xfrm>
              <a:off x="828675" y="3381375"/>
              <a:ext cx="142875" cy="23812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00" name="Group 99"/>
          <p:cNvGrpSpPr/>
          <p:nvPr/>
        </p:nvGrpSpPr>
        <p:grpSpPr>
          <a:xfrm>
            <a:off x="647700" y="4302110"/>
            <a:ext cx="793743" cy="571500"/>
            <a:chOff x="619125" y="3924300"/>
            <a:chExt cx="793743" cy="571500"/>
          </a:xfrm>
        </p:grpSpPr>
        <p:sp>
          <p:nvSpPr>
            <p:cNvPr id="85" name="TextBox 84"/>
            <p:cNvSpPr txBox="1"/>
            <p:nvPr/>
          </p:nvSpPr>
          <p:spPr>
            <a:xfrm>
              <a:off x="619125" y="3924300"/>
              <a:ext cx="7937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>
                  <a:latin typeface="Arial" pitchFamily="34" charset="0"/>
                  <a:cs typeface="Arial" pitchFamily="34" charset="0"/>
                </a:rPr>
                <a:t>IR+Caff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Rectangle 89"/>
            <p:cNvSpPr/>
            <p:nvPr/>
          </p:nvSpPr>
          <p:spPr>
            <a:xfrm>
              <a:off x="904875" y="4257675"/>
              <a:ext cx="142875" cy="23812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01" name="Group 100"/>
          <p:cNvGrpSpPr/>
          <p:nvPr/>
        </p:nvGrpSpPr>
        <p:grpSpPr>
          <a:xfrm>
            <a:off x="644202" y="5178410"/>
            <a:ext cx="1315681" cy="581025"/>
            <a:chOff x="644202" y="4781550"/>
            <a:chExt cx="1315681" cy="581025"/>
          </a:xfrm>
        </p:grpSpPr>
        <p:sp>
          <p:nvSpPr>
            <p:cNvPr id="86" name="TextBox 85"/>
            <p:cNvSpPr txBox="1"/>
            <p:nvPr/>
          </p:nvSpPr>
          <p:spPr>
            <a:xfrm>
              <a:off x="644202" y="4781550"/>
              <a:ext cx="13156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err="1">
                  <a:latin typeface="Arial" pitchFamily="34" charset="0"/>
                  <a:cs typeface="Arial" pitchFamily="34" charset="0"/>
                </a:rPr>
                <a:t>IR+Caff+Taxol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Rectangle 90"/>
            <p:cNvSpPr/>
            <p:nvPr/>
          </p:nvSpPr>
          <p:spPr>
            <a:xfrm>
              <a:off x="885825" y="5124450"/>
              <a:ext cx="142875" cy="23812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bg1"/>
                </a:solidFill>
              </a:endParaRPr>
            </a:p>
          </p:txBody>
        </p:sp>
      </p:grpSp>
      <p:sp>
        <p:nvSpPr>
          <p:cNvPr id="95" name="TextBox 94"/>
          <p:cNvSpPr txBox="1"/>
          <p:nvPr/>
        </p:nvSpPr>
        <p:spPr>
          <a:xfrm>
            <a:off x="695325" y="720710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Mock</a:t>
            </a:r>
          </a:p>
        </p:txBody>
      </p:sp>
      <p:pic>
        <p:nvPicPr>
          <p:cNvPr id="75" name="Picture 2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 t="55157" r="38350"/>
          <a:stretch>
            <a:fillRect/>
          </a:stretch>
        </p:blipFill>
        <p:spPr bwMode="auto">
          <a:xfrm>
            <a:off x="631825" y="1854200"/>
            <a:ext cx="1209675" cy="773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" name="Picture 3"/>
          <p:cNvPicPr>
            <a:picLocks noChangeAspect="1" noChangeArrowheads="1"/>
          </p:cNvPicPr>
          <p:nvPr/>
        </p:nvPicPr>
        <p:blipFill>
          <a:blip r:embed="rId3" cstate="print">
            <a:grayscl/>
          </a:blip>
          <a:srcRect t="58840" r="44822"/>
          <a:stretch>
            <a:fillRect/>
          </a:stretch>
        </p:blipFill>
        <p:spPr bwMode="auto">
          <a:xfrm>
            <a:off x="631825" y="1092200"/>
            <a:ext cx="1082675" cy="7096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3" name="Oval 102"/>
          <p:cNvSpPr/>
          <p:nvPr/>
        </p:nvSpPr>
        <p:spPr>
          <a:xfrm>
            <a:off x="1168400" y="1041400"/>
            <a:ext cx="406400" cy="342900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TextBox 103"/>
          <p:cNvSpPr txBox="1"/>
          <p:nvPr/>
        </p:nvSpPr>
        <p:spPr>
          <a:xfrm>
            <a:off x="631825" y="1749410"/>
            <a:ext cx="8482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Caffeine</a:t>
            </a:r>
          </a:p>
        </p:txBody>
      </p:sp>
      <p:pic>
        <p:nvPicPr>
          <p:cNvPr id="105" name="Picture 6"/>
          <p:cNvPicPr>
            <a:picLocks noChangeAspect="1" noChangeArrowheads="1"/>
          </p:cNvPicPr>
          <p:nvPr/>
        </p:nvPicPr>
        <p:blipFill>
          <a:blip r:embed="rId4" cstate="print">
            <a:grayscl/>
          </a:blip>
          <a:srcRect t="59877" r="45015"/>
          <a:stretch>
            <a:fillRect/>
          </a:stretch>
        </p:blipFill>
        <p:spPr bwMode="auto">
          <a:xfrm>
            <a:off x="631825" y="5511800"/>
            <a:ext cx="1120775" cy="722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6" name="Oval 105"/>
          <p:cNvSpPr/>
          <p:nvPr/>
        </p:nvSpPr>
        <p:spPr>
          <a:xfrm>
            <a:off x="1168400" y="5448300"/>
            <a:ext cx="571500" cy="406400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7" name="Picture 29"/>
          <p:cNvPicPr>
            <a:picLocks noChangeAspect="1" noChangeArrowheads="1"/>
          </p:cNvPicPr>
          <p:nvPr/>
        </p:nvPicPr>
        <p:blipFill>
          <a:blip r:embed="rId3" cstate="print">
            <a:grayscl/>
          </a:blip>
          <a:srcRect t="56630" r="44822"/>
          <a:stretch>
            <a:fillRect/>
          </a:stretch>
        </p:blipFill>
        <p:spPr bwMode="auto">
          <a:xfrm>
            <a:off x="644525" y="4610100"/>
            <a:ext cx="1082675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8" name="Oval 107"/>
          <p:cNvSpPr/>
          <p:nvPr/>
        </p:nvSpPr>
        <p:spPr>
          <a:xfrm>
            <a:off x="1168400" y="4572000"/>
            <a:ext cx="495300" cy="304800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9" name="Picture 8"/>
          <p:cNvPicPr>
            <a:picLocks noChangeAspect="1" noChangeArrowheads="1"/>
          </p:cNvPicPr>
          <p:nvPr/>
        </p:nvPicPr>
        <p:blipFill>
          <a:blip r:embed="rId5" cstate="print">
            <a:grayscl/>
          </a:blip>
          <a:srcRect t="58103" r="45470"/>
          <a:stretch>
            <a:fillRect/>
          </a:stretch>
        </p:blipFill>
        <p:spPr bwMode="auto">
          <a:xfrm>
            <a:off x="619125" y="2819400"/>
            <a:ext cx="1069975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0" name="Oval 109"/>
          <p:cNvSpPr/>
          <p:nvPr/>
        </p:nvSpPr>
        <p:spPr>
          <a:xfrm>
            <a:off x="1168400" y="2743200"/>
            <a:ext cx="508000" cy="317500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1" name="Picture 10"/>
          <p:cNvPicPr>
            <a:picLocks noChangeAspect="1" noChangeArrowheads="1"/>
          </p:cNvPicPr>
          <p:nvPr/>
        </p:nvPicPr>
        <p:blipFill>
          <a:blip r:embed="rId6" cstate="print">
            <a:grayscl/>
          </a:blip>
          <a:srcRect t="53922" r="44175"/>
          <a:stretch>
            <a:fillRect/>
          </a:stretch>
        </p:blipFill>
        <p:spPr bwMode="auto">
          <a:xfrm>
            <a:off x="619125" y="3746500"/>
            <a:ext cx="1095375" cy="596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2" name="Oval 111"/>
          <p:cNvSpPr/>
          <p:nvPr/>
        </p:nvSpPr>
        <p:spPr>
          <a:xfrm>
            <a:off x="1143000" y="3683000"/>
            <a:ext cx="495300" cy="381000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Oval 112"/>
          <p:cNvSpPr/>
          <p:nvPr/>
        </p:nvSpPr>
        <p:spPr>
          <a:xfrm>
            <a:off x="1104900" y="2032000"/>
            <a:ext cx="406400" cy="241300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TextBox 113"/>
          <p:cNvSpPr txBox="1"/>
          <p:nvPr/>
        </p:nvSpPr>
        <p:spPr>
          <a:xfrm>
            <a:off x="1638300" y="8128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1612900" y="18161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pic>
        <p:nvPicPr>
          <p:cNvPr id="116" name="Picture 115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3365500" y="626533"/>
            <a:ext cx="3492500" cy="2997200"/>
          </a:xfrm>
          <a:prstGeom prst="rect">
            <a:avLst/>
          </a:prstGeom>
        </p:spPr>
      </p:pic>
      <p:pic>
        <p:nvPicPr>
          <p:cNvPr id="117" name="Picture 2"/>
          <p:cNvPicPr>
            <a:picLocks noChangeAspect="1" noChangeArrowheads="1"/>
          </p:cNvPicPr>
          <p:nvPr/>
        </p:nvPicPr>
        <p:blipFill>
          <a:blip r:embed="rId8" cstate="print"/>
          <a:srcRect l="11087" r="43443"/>
          <a:stretch>
            <a:fillRect/>
          </a:stretch>
        </p:blipFill>
        <p:spPr bwMode="auto">
          <a:xfrm>
            <a:off x="2235200" y="3340101"/>
            <a:ext cx="927100" cy="774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9" name="Picture 10"/>
          <p:cNvPicPr preferRelativeResize="0">
            <a:picLocks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13" r="9418"/>
          <a:stretch/>
        </p:blipFill>
        <p:spPr bwMode="auto">
          <a:xfrm>
            <a:off x="2078569" y="863600"/>
            <a:ext cx="897465" cy="7027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23" name="Picture 11"/>
          <p:cNvPicPr preferRelativeResize="0">
            <a:picLocks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46" r="49533"/>
          <a:stretch/>
        </p:blipFill>
        <p:spPr bwMode="auto">
          <a:xfrm>
            <a:off x="2023534" y="2463799"/>
            <a:ext cx="1113366" cy="685559"/>
          </a:xfrm>
          <a:prstGeom prst="rect">
            <a:avLst/>
          </a:prstGeom>
          <a:noFill/>
          <a:ln>
            <a:solidFill>
              <a:srgbClr val="FFFFFF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24" name="Picture 13"/>
          <p:cNvPicPr preferRelativeResize="0">
            <a:picLocks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40" r="24398"/>
          <a:stretch/>
        </p:blipFill>
        <p:spPr bwMode="auto">
          <a:xfrm>
            <a:off x="2167466" y="1727200"/>
            <a:ext cx="817033" cy="602581"/>
          </a:xfrm>
          <a:prstGeom prst="rect">
            <a:avLst/>
          </a:prstGeom>
          <a:noFill/>
          <a:ln>
            <a:solidFill>
              <a:srgbClr val="FFFFFF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25" name="Picture 14"/>
          <p:cNvPicPr preferRelativeResize="0">
            <a:picLocks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39" r="20321"/>
          <a:stretch/>
        </p:blipFill>
        <p:spPr bwMode="auto">
          <a:xfrm>
            <a:off x="2099732" y="4229100"/>
            <a:ext cx="1024468" cy="825499"/>
          </a:xfrm>
          <a:prstGeom prst="rect">
            <a:avLst/>
          </a:prstGeom>
          <a:noFill/>
          <a:ln>
            <a:solidFill>
              <a:srgbClr val="FFFFFF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391198" name="Picture 30"/>
          <p:cNvPicPr>
            <a:picLocks noChangeAspect="1" noChangeArrowheads="1"/>
          </p:cNvPicPr>
          <p:nvPr/>
        </p:nvPicPr>
        <p:blipFill>
          <a:blip r:embed="rId13" cstate="print"/>
          <a:srcRect l="6914" t="17025" r="45924"/>
          <a:stretch>
            <a:fillRect/>
          </a:stretch>
        </p:blipFill>
        <p:spPr bwMode="auto">
          <a:xfrm>
            <a:off x="2095500" y="5245100"/>
            <a:ext cx="1028700" cy="91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5" name="TextBox 7"/>
          <p:cNvSpPr txBox="1"/>
          <p:nvPr/>
        </p:nvSpPr>
        <p:spPr>
          <a:xfrm>
            <a:off x="254000" y="6731000"/>
            <a:ext cx="660400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  <a:tabLst>
                <a:tab pos="1638300" algn="l"/>
              </a:tabLst>
            </a:pPr>
            <a:endParaRPr lang="en-US" sz="1200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  <a:tabLst>
                <a:tab pos="-857250" algn="l"/>
              </a:tabLst>
            </a:pPr>
            <a:endParaRPr lang="en-US" sz="1200" dirty="0">
              <a:latin typeface="Times New Roman" pitchFamily="18" charset="0"/>
              <a:cs typeface="Times New Roman" pitchFamily="18" charset="0"/>
            </a:endParaRPr>
          </a:p>
          <a:p>
            <a:pPr algn="just" fontAlgn="base">
              <a:spcBef>
                <a:spcPct val="0"/>
              </a:spcBef>
              <a:spcAft>
                <a:spcPct val="0"/>
              </a:spcAft>
              <a:tabLst>
                <a:tab pos="-857250" algn="l"/>
              </a:tabLst>
            </a:pP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5: Uhth74 cell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ypass the mitotic checkpoint induced by γ−irradiation in presence of UCN-01 or caffeine </a:t>
            </a:r>
          </a:p>
          <a:p>
            <a:pPr algn="just" fontAlgn="base">
              <a:spcBef>
                <a:spcPct val="0"/>
              </a:spcBef>
              <a:spcAft>
                <a:spcPct val="0"/>
              </a:spcAft>
              <a:tabLst>
                <a:tab pos="-857250" algn="l"/>
              </a:tabLst>
            </a:pP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(</a:t>
            </a: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) Mitotic trap assay. Three hours after </a:t>
            </a:r>
            <a:r>
              <a:rPr lang="en-US" sz="1200" dirty="0">
                <a:latin typeface="Symbol" charset="2"/>
                <a:ea typeface="Calibri" pitchFamily="34" charset="0"/>
                <a:cs typeface="Symbol" charset="2"/>
              </a:rPr>
              <a:t>g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-irradiation (IR), UCN-01 (50nM, UCN) and/or caffeine (2.5mM,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aff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), Uhth74 cells were incubated with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axol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t 50nM. Sixteen hours later, cells were fixed with chilled 70% ethanol. Cells were labeled with a histone 3 anti-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hosphoserine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10 (H3pSer10) antibody, stained with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ropidium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iodide and analyzed by flow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ytometry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(</a:t>
            </a: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) The percentages of H3pSer10-positive Uhth74 cells were determined from three independent experiments. *** indicates p &lt;0.001. Statistical significance was determined by one-way analysis of variance (ANOVA) followed by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ukey’s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multiple comparisons test.</a:t>
            </a:r>
          </a:p>
        </p:txBody>
      </p:sp>
    </p:spTree>
    <p:extLst>
      <p:ext uri="{BB962C8B-B14F-4D97-AF65-F5344CB8AC3E}">
        <p14:creationId xmlns:p14="http://schemas.microsoft.com/office/powerpoint/2010/main" val="24742596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214" name="Picture 6"/>
          <p:cNvPicPr>
            <a:picLocks noChangeAspect="1" noChangeArrowheads="1"/>
          </p:cNvPicPr>
          <p:nvPr/>
        </p:nvPicPr>
        <p:blipFill>
          <a:blip r:embed="rId2" cstate="print"/>
          <a:srcRect l="4762" t="11628"/>
          <a:stretch>
            <a:fillRect/>
          </a:stretch>
        </p:blipFill>
        <p:spPr bwMode="auto">
          <a:xfrm>
            <a:off x="1913470" y="2544233"/>
            <a:ext cx="3048000" cy="26295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4218" name="Picture 10"/>
          <p:cNvPicPr>
            <a:picLocks noChangeAspect="1" noChangeArrowheads="1"/>
          </p:cNvPicPr>
          <p:nvPr/>
        </p:nvPicPr>
        <p:blipFill>
          <a:blip r:embed="rId3" cstate="print"/>
          <a:srcRect l="2381" t="12791"/>
          <a:stretch>
            <a:fillRect/>
          </a:stretch>
        </p:blipFill>
        <p:spPr bwMode="auto">
          <a:xfrm>
            <a:off x="1833563" y="165095"/>
            <a:ext cx="3124200" cy="26019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4219" name="Picture 11"/>
          <p:cNvPicPr>
            <a:picLocks noChangeAspect="1" noChangeArrowheads="1"/>
          </p:cNvPicPr>
          <p:nvPr/>
        </p:nvPicPr>
        <p:blipFill rotWithShape="1">
          <a:blip r:embed="rId4" cstate="print"/>
          <a:srcRect l="2156" t="19015"/>
          <a:stretch/>
        </p:blipFill>
        <p:spPr bwMode="auto">
          <a:xfrm>
            <a:off x="1835574" y="5283200"/>
            <a:ext cx="3108960" cy="23860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15"/>
          <p:cNvSpPr txBox="1"/>
          <p:nvPr/>
        </p:nvSpPr>
        <p:spPr>
          <a:xfrm>
            <a:off x="720571" y="982134"/>
            <a:ext cx="710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643</a:t>
            </a:r>
          </a:p>
        </p:txBody>
      </p:sp>
      <p:sp>
        <p:nvSpPr>
          <p:cNvPr id="11" name="TextBox 15"/>
          <p:cNvSpPr txBox="1"/>
          <p:nvPr/>
        </p:nvSpPr>
        <p:spPr>
          <a:xfrm>
            <a:off x="644371" y="3494477"/>
            <a:ext cx="862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PC-1</a:t>
            </a:r>
          </a:p>
        </p:txBody>
      </p:sp>
      <p:sp>
        <p:nvSpPr>
          <p:cNvPr id="12" name="TextBox 15"/>
          <p:cNvSpPr txBox="1"/>
          <p:nvPr/>
        </p:nvSpPr>
        <p:spPr>
          <a:xfrm>
            <a:off x="580496" y="6237299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hth74</a:t>
            </a:r>
          </a:p>
        </p:txBody>
      </p:sp>
      <p:sp>
        <p:nvSpPr>
          <p:cNvPr id="13" name="ZoneTexte 23"/>
          <p:cNvSpPr txBox="1"/>
          <p:nvPr/>
        </p:nvSpPr>
        <p:spPr>
          <a:xfrm>
            <a:off x="5879017" y="8774674"/>
            <a:ext cx="10742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itchFamily="34" charset="0"/>
                <a:cs typeface="Arial" pitchFamily="34" charset="0"/>
              </a:rPr>
              <a:t>Figure S6</a:t>
            </a:r>
          </a:p>
        </p:txBody>
      </p:sp>
      <p:sp>
        <p:nvSpPr>
          <p:cNvPr id="9" name="TextBox 7"/>
          <p:cNvSpPr txBox="1"/>
          <p:nvPr/>
        </p:nvSpPr>
        <p:spPr>
          <a:xfrm>
            <a:off x="139700" y="7467600"/>
            <a:ext cx="6604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just"/>
            <a:endParaRPr lang="en-US" sz="1200" i="1" dirty="0">
              <a:latin typeface="Times New Roman" pitchFamily="18" charset="0"/>
              <a:cs typeface="Times New Roman" pitchFamily="18" charset="0"/>
            </a:endParaRPr>
          </a:p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6. Apoptosis of thyroid cancer cells in response to SCR-7, RI-1 and doxorubicin </a:t>
            </a:r>
          </a:p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hyroid  cancer  cell lines C643, TPC-1 and Uhth74 were treated with SCR-7, RI-and/or doxorubicin. After 48 hours, cells were fixed with chilled 70% ethanol, labeled with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ropidium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iodide and analyzed by flow </a:t>
            </a:r>
            <a:r>
              <a:rPr 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ytometry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After exclusion of doublets, cells staining in sub-G1 were considered as having undergone DNA fragmentation. Data represent the means ±SEs of three independent experiments. ** p-value&lt;0.1, *** p-value&lt;0.001 and ns (not significant) p value&gt;0.05.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2886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4BF7B0B27692148B5B3A8916168065D" ma:contentTypeVersion="13" ma:contentTypeDescription="Crée un document." ma:contentTypeScope="" ma:versionID="64f5494b6577be4d6967b802c83b63f4">
  <xsd:schema xmlns:xsd="http://www.w3.org/2001/XMLSchema" xmlns:xs="http://www.w3.org/2001/XMLSchema" xmlns:p="http://schemas.microsoft.com/office/2006/metadata/properties" xmlns:ns2="a238498b-f08d-448e-8dbd-abe85e2249af" xmlns:ns3="348b7af1-40da-4f1a-9141-119420732c3a" targetNamespace="http://schemas.microsoft.com/office/2006/metadata/properties" ma:root="true" ma:fieldsID="394e0551a47d970bff3ef6f4cebaffc3" ns2:_="" ns3:_="">
    <xsd:import namespace="a238498b-f08d-448e-8dbd-abe85e2249af"/>
    <xsd:import namespace="348b7af1-40da-4f1a-9141-119420732c3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38498b-f08d-448e-8dbd-abe85e2249a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5" nillable="true" ma:taxonomy="true" ma:internalName="lcf76f155ced4ddcb4097134ff3c332f" ma:taxonomyFieldName="MediaServiceImageTags" ma:displayName="Balises d’images" ma:readOnly="false" ma:fieldId="{5cf76f15-5ced-4ddc-b409-7134ff3c332f}" ma:taxonomyMulti="true" ma:sspId="4434ded7-6e41-4000-8be6-3d063d771b34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48b7af1-40da-4f1a-9141-119420732c3a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6" nillable="true" ma:displayName="Taxonomy Catch All Column" ma:hidden="true" ma:list="{fa100b41-3bbc-4a24-86b8-efb800945246}" ma:internalName="TaxCatchAll" ma:showField="CatchAllData" ma:web="348b7af1-40da-4f1a-9141-119420732c3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348b7af1-40da-4f1a-9141-119420732c3a" xsi:nil="true"/>
    <lcf76f155ced4ddcb4097134ff3c332f xmlns="a238498b-f08d-448e-8dbd-abe85e2249af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48E9600F-08B2-4B70-8788-657E6843E50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238498b-f08d-448e-8dbd-abe85e2249af"/>
    <ds:schemaRef ds:uri="348b7af1-40da-4f1a-9141-119420732c3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AC2D4D3-0446-4CE0-925C-121314F360FA}">
  <ds:schemaRefs>
    <ds:schemaRef ds:uri="http://schemas.microsoft.com/office/2006/metadata/properties"/>
    <ds:schemaRef ds:uri="http://schemas.microsoft.com/office/infopath/2007/PartnerControls"/>
    <ds:schemaRef ds:uri="348b7af1-40da-4f1a-9141-119420732c3a"/>
    <ds:schemaRef ds:uri="a238498b-f08d-448e-8dbd-abe85e2249af"/>
  </ds:schemaRefs>
</ds:datastoreItem>
</file>

<file path=customXml/itemProps3.xml><?xml version="1.0" encoding="utf-8"?>
<ds:datastoreItem xmlns:ds="http://schemas.openxmlformats.org/officeDocument/2006/customXml" ds:itemID="{60A333D1-BFCE-4948-9480-4DA83C734519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63</Words>
  <Application>Microsoft Office PowerPoint</Application>
  <PresentationFormat>Affichage à l'écran (4:3)</PresentationFormat>
  <Paragraphs>425</Paragraphs>
  <Slides>6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1" baseType="lpstr">
      <vt:lpstr>Arial</vt:lpstr>
      <vt:lpstr>Calibri</vt:lpstr>
      <vt:lpstr>Symbol</vt:lpstr>
      <vt:lpstr>Times New Roman</vt:lpstr>
      <vt:lpstr>Office Them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indows User</dc:creator>
  <cp:lastModifiedBy>Malik Hamaidia</cp:lastModifiedBy>
  <cp:revision>445</cp:revision>
  <cp:lastPrinted>2016-11-02T11:12:12Z</cp:lastPrinted>
  <dcterms:created xsi:type="dcterms:W3CDTF">2016-02-18T09:31:43Z</dcterms:created>
  <dcterms:modified xsi:type="dcterms:W3CDTF">2023-08-25T09:08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4BF7B0B27692148B5B3A8916168065D</vt:lpwstr>
  </property>
</Properties>
</file>